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6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CC830A90-5788-477C-9400-2941EEDBA935}"/>
              </a:ext>
            </a:extLst>
          </p:cNvPr>
          <p:cNvGrpSpPr/>
          <p:nvPr/>
        </p:nvGrpSpPr>
        <p:grpSpPr>
          <a:xfrm>
            <a:off x="2216616" y="2527963"/>
            <a:ext cx="2320718" cy="2434790"/>
            <a:chOff x="1839374" y="5715926"/>
            <a:chExt cx="2896504" cy="240961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6A78249-0DDD-4801-9F8E-F80BB942F4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41088" y="7743479"/>
              <a:ext cx="1859087" cy="38206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E00CC62-4CA0-4DCD-AB01-9CF95EBB32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39374" y="6617108"/>
              <a:ext cx="1862084" cy="35798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355C47F-305D-4D68-98C6-F46469F42E5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39374" y="7358587"/>
              <a:ext cx="1862084" cy="35649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05883A9-4D24-4E2E-81F5-C15270FB742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39374" y="6994895"/>
              <a:ext cx="1862084" cy="33332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F11E94A-5127-423A-9929-1C8A732E386A}"/>
                </a:ext>
              </a:extLst>
            </p:cNvPr>
            <p:cNvSpPr txBox="1"/>
            <p:nvPr/>
          </p:nvSpPr>
          <p:spPr>
            <a:xfrm>
              <a:off x="2042965" y="5715926"/>
              <a:ext cx="662639" cy="258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47D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0F33124A-C1AA-4CE0-BED3-6100090898E1}"/>
                </a:ext>
              </a:extLst>
            </p:cNvPr>
            <p:cNvCxnSpPr/>
            <p:nvPr/>
          </p:nvCxnSpPr>
          <p:spPr>
            <a:xfrm flipV="1">
              <a:off x="1982069" y="6021385"/>
              <a:ext cx="882293" cy="1027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9E0A336-4882-4CF4-B89F-74569B072151}"/>
                </a:ext>
              </a:extLst>
            </p:cNvPr>
            <p:cNvSpPr txBox="1"/>
            <p:nvPr/>
          </p:nvSpPr>
          <p:spPr>
            <a:xfrm rot="16200000">
              <a:off x="1825049" y="6217351"/>
              <a:ext cx="455623" cy="326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BCB110A-13BE-4857-921C-D0F945FAA2BC}"/>
                </a:ext>
              </a:extLst>
            </p:cNvPr>
            <p:cNvSpPr txBox="1"/>
            <p:nvPr/>
          </p:nvSpPr>
          <p:spPr>
            <a:xfrm rot="16200000">
              <a:off x="2092929" y="6201822"/>
              <a:ext cx="571433" cy="326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2-E7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743852B-9E1A-4CFA-92E5-A566EC19F99B}"/>
                </a:ext>
              </a:extLst>
            </p:cNvPr>
            <p:cNvSpPr txBox="1"/>
            <p:nvPr/>
          </p:nvSpPr>
          <p:spPr>
            <a:xfrm rot="16200000">
              <a:off x="2428320" y="6143704"/>
              <a:ext cx="649168" cy="326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2-E1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DF0FEA2-BA40-4832-93C5-29554E6EDCB9}"/>
                </a:ext>
              </a:extLst>
            </p:cNvPr>
            <p:cNvSpPr txBox="1"/>
            <p:nvPr/>
          </p:nvSpPr>
          <p:spPr>
            <a:xfrm rot="16200000">
              <a:off x="2738488" y="6059006"/>
              <a:ext cx="798292" cy="326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CC1428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EB9024F-7229-4A6B-86E5-E460F4E45C1C}"/>
                </a:ext>
              </a:extLst>
            </p:cNvPr>
            <p:cNvSpPr txBox="1"/>
            <p:nvPr/>
          </p:nvSpPr>
          <p:spPr>
            <a:xfrm rot="16200000">
              <a:off x="3144615" y="6127123"/>
              <a:ext cx="695174" cy="326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ZR-75-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AD06AFF-ABC7-4FE0-9CEB-79D6C1B1A0C6}"/>
                </a:ext>
              </a:extLst>
            </p:cNvPr>
            <p:cNvSpPr txBox="1"/>
            <p:nvPr/>
          </p:nvSpPr>
          <p:spPr>
            <a:xfrm>
              <a:off x="3623358" y="6647258"/>
              <a:ext cx="960064" cy="258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ER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48604AB-01C6-4F95-B17E-F4244FD98382}"/>
                </a:ext>
              </a:extLst>
            </p:cNvPr>
            <p:cNvSpPr txBox="1"/>
            <p:nvPr/>
          </p:nvSpPr>
          <p:spPr>
            <a:xfrm>
              <a:off x="3623358" y="7020353"/>
              <a:ext cx="960064" cy="258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ER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0FB37DE-2B0A-4B5A-B759-6BEEC0AE5622}"/>
                </a:ext>
              </a:extLst>
            </p:cNvPr>
            <p:cNvSpPr txBox="1"/>
            <p:nvPr/>
          </p:nvSpPr>
          <p:spPr>
            <a:xfrm>
              <a:off x="3624561" y="7374350"/>
              <a:ext cx="832205" cy="258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R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622C42D-B14B-48E2-AB87-A265DCB1BF57}"/>
                </a:ext>
              </a:extLst>
            </p:cNvPr>
            <p:cNvSpPr txBox="1"/>
            <p:nvPr/>
          </p:nvSpPr>
          <p:spPr>
            <a:xfrm>
              <a:off x="3624562" y="7778565"/>
              <a:ext cx="1111316" cy="258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21" name="Rectangle 20">
            <a:extLst>
              <a:ext uri="{FF2B5EF4-FFF2-40B4-BE49-F238E27FC236}">
                <a16:creationId xmlns:a16="http://schemas.microsoft.com/office/drawing/2014/main" id="{22A90017-AFE9-416A-B546-94DC44AE6C72}"/>
              </a:ext>
            </a:extLst>
          </p:cNvPr>
          <p:cNvSpPr/>
          <p:nvPr/>
        </p:nvSpPr>
        <p:spPr>
          <a:xfrm>
            <a:off x="657508" y="5343713"/>
            <a:ext cx="554298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9. 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Western blots detecting HER2, HER3, and SRC protein expression in the cell line models used in the preliminary study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80097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36</Words>
  <Application>Microsoft Office PowerPoint</Application>
  <PresentationFormat>信纸(8.5x11 英寸)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8:21Z</dcterms:modified>
</cp:coreProperties>
</file>